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1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38" autoAdjust="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64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0" y="0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1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/>
              <a:t>HIF-1 direct targets </a:t>
            </a:r>
            <a:r>
              <a:rPr lang="en-US" sz="1000" b="1" dirty="0" err="1"/>
              <a:t>ChIP-seq</a:t>
            </a:r>
            <a:r>
              <a:rPr lang="en-US" sz="1000" b="1" dirty="0"/>
              <a:t> IGB </a:t>
            </a:r>
            <a:r>
              <a:rPr lang="en-US" sz="1000" b="1" dirty="0" smtClean="0"/>
              <a:t>signals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1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minimum number for the y-axis scale was the normalized average input tag count, and the maximum number was the averag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 count (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9 Table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WIG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r IGB was provided in GEO database (accession number </a:t>
            </a:r>
            <a:r>
              <a:rPr lang="en-US" sz="1000" dirty="0"/>
              <a:t>GSE22884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1017799"/>
            <a:ext cx="17047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8G1BL.8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70802" y="3658681"/>
            <a:ext cx="4931314" cy="2586449"/>
            <a:chOff x="409165" y="3380215"/>
            <a:chExt cx="4931314" cy="2586449"/>
          </a:xfrm>
        </p:grpSpPr>
        <p:sp>
          <p:nvSpPr>
            <p:cNvPr id="16" name="TextBox 15"/>
            <p:cNvSpPr txBox="1"/>
            <p:nvPr/>
          </p:nvSpPr>
          <p:spPr>
            <a:xfrm>
              <a:off x="409165" y="3380215"/>
              <a:ext cx="956930" cy="2485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f-25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534325" y="3640510"/>
              <a:ext cx="4806154" cy="2326154"/>
              <a:chOff x="470527" y="3640510"/>
              <a:chExt cx="4806154" cy="2326154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0527" y="3640510"/>
                <a:ext cx="4806154" cy="2326154"/>
              </a:xfrm>
              <a:prstGeom prst="rect">
                <a:avLst/>
              </a:prstGeom>
            </p:spPr>
          </p:pic>
          <p:sp>
            <p:nvSpPr>
              <p:cNvPr id="35" name="TextBox 34"/>
              <p:cNvSpPr txBox="1"/>
              <p:nvPr/>
            </p:nvSpPr>
            <p:spPr>
              <a:xfrm>
                <a:off x="2905726" y="5283450"/>
                <a:ext cx="10595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10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f-25</a:t>
                </a:r>
                <a:endParaRPr 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82" y="1258906"/>
            <a:ext cx="4806154" cy="2326154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>
            <a:off x="133381" y="1284725"/>
            <a:ext cx="1152196" cy="1994880"/>
            <a:chOff x="377929" y="671089"/>
            <a:chExt cx="1152196" cy="1994880"/>
          </a:xfrm>
        </p:grpSpPr>
        <p:grpSp>
          <p:nvGrpSpPr>
            <p:cNvPr id="5" name="Group 4"/>
            <p:cNvGrpSpPr/>
            <p:nvPr/>
          </p:nvGrpSpPr>
          <p:grpSpPr>
            <a:xfrm>
              <a:off x="377929" y="671089"/>
              <a:ext cx="1152195" cy="1421772"/>
              <a:chOff x="470526" y="6079802"/>
              <a:chExt cx="1152195" cy="1421772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470526" y="6079802"/>
                <a:ext cx="10533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err="1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put_Bio</a:t>
                </a:r>
                <a:r>
                  <a:rPr lang="en-US" sz="1000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p1</a:t>
                </a:r>
                <a:endParaRPr lang="en-US" sz="1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70526" y="6885548"/>
                <a:ext cx="1152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err="1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put_Bio</a:t>
                </a:r>
                <a:r>
                  <a:rPr lang="en-US" sz="1000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p2</a:t>
                </a:r>
                <a:endParaRPr lang="en-US" sz="1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70527" y="6449607"/>
                <a:ext cx="9798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err="1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P_Bio</a:t>
                </a:r>
                <a:r>
                  <a:rPr lang="en-US" sz="10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p1</a:t>
                </a:r>
                <a:endPara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70527" y="7255353"/>
                <a:ext cx="9798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err="1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P_Bio</a:t>
                </a:r>
                <a:r>
                  <a:rPr lang="en-US" sz="10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p2</a:t>
                </a:r>
                <a:endPara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470527" y="2419748"/>
              <a:ext cx="1059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48G1BL.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115875" y="6315705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T06A4.1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03" y="6724993"/>
            <a:ext cx="4806154" cy="2326154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1097160" y="8481292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06A4.1</a:t>
            </a:r>
          </a:p>
        </p:txBody>
      </p:sp>
      <p:grpSp>
        <p:nvGrpSpPr>
          <p:cNvPr id="33" name="Group 32"/>
          <p:cNvGrpSpPr/>
          <p:nvPr/>
        </p:nvGrpSpPr>
        <p:grpSpPr>
          <a:xfrm>
            <a:off x="276277" y="3924497"/>
            <a:ext cx="1152195" cy="1421772"/>
            <a:chOff x="470526" y="6079802"/>
            <a:chExt cx="1152195" cy="1421772"/>
          </a:xfrm>
        </p:grpSpPr>
        <p:sp>
          <p:nvSpPr>
            <p:cNvPr id="44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418583" y="6724993"/>
            <a:ext cx="1152195" cy="1421772"/>
            <a:chOff x="470526" y="6079802"/>
            <a:chExt cx="1152195" cy="1421772"/>
          </a:xfrm>
        </p:grpSpPr>
        <p:sp>
          <p:nvSpPr>
            <p:cNvPr id="49" name="TextBox 48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tg-5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788" y="265012"/>
            <a:ext cx="4806154" cy="2326154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37857" y="264516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40E3.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54" y="2947696"/>
            <a:ext cx="4806154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238153" y="4785855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40E3.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ol-52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6" y="5645962"/>
            <a:ext cx="4806154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716618" y="7495592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ol-52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399954" y="1780089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g-5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247759" y="222859"/>
            <a:ext cx="1152195" cy="1421772"/>
            <a:chOff x="470526" y="6079802"/>
            <a:chExt cx="1152195" cy="1421772"/>
          </a:xfrm>
        </p:grpSpPr>
        <p:sp>
          <p:nvSpPr>
            <p:cNvPr id="38" name="TextBox 37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269792" y="2905001"/>
            <a:ext cx="1152195" cy="1421772"/>
            <a:chOff x="470526" y="6079802"/>
            <a:chExt cx="1152195" cy="1421772"/>
          </a:xfrm>
        </p:grpSpPr>
        <p:sp>
          <p:nvSpPr>
            <p:cNvPr id="45" name="TextBox 44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58798" y="5630380"/>
            <a:ext cx="1152195" cy="1421772"/>
            <a:chOff x="470526" y="6079802"/>
            <a:chExt cx="1152195" cy="1421772"/>
          </a:xfrm>
        </p:grpSpPr>
        <p:sp>
          <p:nvSpPr>
            <p:cNvPr id="50" name="TextBox 49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2346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04F3.3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/kin-3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qn-44/tent-5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I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70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54" y="273507"/>
            <a:ext cx="4806154" cy="232615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86707" y="2091299"/>
            <a:ext cx="1249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04F3.3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/kin-35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6" y="2944948"/>
            <a:ext cx="4806154" cy="2326154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2647506" y="4658265"/>
            <a:ext cx="7037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qn-44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6" y="5782859"/>
            <a:ext cx="4806154" cy="232615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2042459" y="7399899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sp-70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255819" y="266654"/>
            <a:ext cx="1152195" cy="1421772"/>
            <a:chOff x="470526" y="6079802"/>
            <a:chExt cx="1152195" cy="1421772"/>
          </a:xfrm>
        </p:grpSpPr>
        <p:sp>
          <p:nvSpPr>
            <p:cNvPr id="37" name="TextBox 36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02248" y="2907308"/>
            <a:ext cx="1152195" cy="1421772"/>
            <a:chOff x="470526" y="6079802"/>
            <a:chExt cx="1152195" cy="1421772"/>
          </a:xfrm>
        </p:grpSpPr>
        <p:sp>
          <p:nvSpPr>
            <p:cNvPr id="46" name="TextBox 45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754435"/>
            <a:ext cx="1152195" cy="1421772"/>
            <a:chOff x="470526" y="6079802"/>
            <a:chExt cx="1152195" cy="1421772"/>
          </a:xfrm>
        </p:grpSpPr>
        <p:sp>
          <p:nvSpPr>
            <p:cNvPr id="51" name="TextBox 50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4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J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vab-1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053.1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ns-30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687" y="302088"/>
            <a:ext cx="4806154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215116" y="1890207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vab-10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6" y="2908974"/>
            <a:ext cx="4806154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215116" y="4728118"/>
            <a:ext cx="796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ZK1053.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175" y="5717666"/>
            <a:ext cx="4806154" cy="2326154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3354447" y="7548754"/>
            <a:ext cx="654027" cy="255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s-30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336362" y="316913"/>
            <a:ext cx="1152195" cy="1421772"/>
            <a:chOff x="470526" y="6079802"/>
            <a:chExt cx="1152195" cy="1421772"/>
          </a:xfrm>
        </p:grpSpPr>
        <p:sp>
          <p:nvSpPr>
            <p:cNvPr id="30" name="TextBox 29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41381" y="2890435"/>
            <a:ext cx="1152195" cy="1421772"/>
            <a:chOff x="470526" y="6079802"/>
            <a:chExt cx="1152195" cy="1421772"/>
          </a:xfrm>
        </p:grpSpPr>
        <p:sp>
          <p:nvSpPr>
            <p:cNvPr id="46" name="TextBox 45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92070"/>
            <a:ext cx="1152195" cy="1421772"/>
            <a:chOff x="470526" y="6079802"/>
            <a:chExt cx="1152195" cy="1421772"/>
          </a:xfrm>
        </p:grpSpPr>
        <p:sp>
          <p:nvSpPr>
            <p:cNvPr id="51" name="TextBox 50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8162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M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ro-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N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05E8B.9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O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dnj-12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6" y="244476"/>
            <a:ext cx="4806154" cy="2326154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4512629" y="1697414"/>
            <a:ext cx="6654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ro-1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485" y="2877786"/>
            <a:ext cx="4806154" cy="232615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298346" y="4391775"/>
            <a:ext cx="8793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105E8B.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118" y="5716688"/>
            <a:ext cx="4806154" cy="2326154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3131163" y="7219145"/>
            <a:ext cx="6646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dnj-12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338963" y="244476"/>
            <a:ext cx="1152195" cy="1421772"/>
            <a:chOff x="470526" y="6079802"/>
            <a:chExt cx="1152195" cy="1421772"/>
          </a:xfrm>
        </p:grpSpPr>
        <p:sp>
          <p:nvSpPr>
            <p:cNvPr id="30" name="TextBox 29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338963" y="2845991"/>
            <a:ext cx="1152195" cy="1421772"/>
            <a:chOff x="470526" y="6079802"/>
            <a:chExt cx="1152195" cy="1421772"/>
          </a:xfrm>
        </p:grpSpPr>
        <p:sp>
          <p:nvSpPr>
            <p:cNvPr id="40" name="TextBox 39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8963" y="5692933"/>
            <a:ext cx="1152195" cy="1421772"/>
            <a:chOff x="470526" y="6079802"/>
            <a:chExt cx="1152195" cy="1421772"/>
          </a:xfrm>
        </p:grpSpPr>
        <p:sp>
          <p:nvSpPr>
            <p:cNvPr id="51" name="TextBox 50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268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</TotalTime>
  <Words>252</Words>
  <Application>Microsoft Office PowerPoint</Application>
  <PresentationFormat>On-screen Show (4:3)</PresentationFormat>
  <Paragraphs>9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35</cp:revision>
  <cp:lastPrinted>2023-01-23T06:24:09Z</cp:lastPrinted>
  <dcterms:created xsi:type="dcterms:W3CDTF">2023-01-23T06:15:50Z</dcterms:created>
  <dcterms:modified xsi:type="dcterms:W3CDTF">2023-10-23T07:43:36Z</dcterms:modified>
</cp:coreProperties>
</file>